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8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4"/>
  </p:normalViewPr>
  <p:slideViewPr>
    <p:cSldViewPr snapToGrid="0" showGuides="1">
      <p:cViewPr varScale="1">
        <p:scale>
          <a:sx n="104" d="100"/>
          <a:sy n="104" d="100"/>
        </p:scale>
        <p:origin x="800" y="2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566538-5A8D-B744-93D0-372D98DA506B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E26691-A37D-854D-B067-3550A0B291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8581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fr-FR" altLang="ja-JP" dirty="0"/>
              <a:t>Graph +++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45EE1-89D3-4D4D-9F53-85E174357F6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0003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4E049F-3457-41C8-3B3B-097F369F7D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AD2FC4D-25CE-96F5-A348-6F080C0293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1AAE9F-DB46-8C23-4BE6-4E6228726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BEF1EB-EDA5-944D-ED80-98BEBDB0C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F151B8-0CF1-4DCA-5E34-ECD08F1E1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326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84780A-7830-93CD-8AD9-2FCC05B969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8AB4588-BFE0-AA0F-F947-7BCF313F6C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C10A17-B41A-9BD6-8D65-317C80CBB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68A6CF-5B24-8CF3-E2C1-675D43D58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06D950-C2AA-7966-EC97-E884445DC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4595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E1DE1B6-1A2E-37C7-37F4-810DDC78F7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298202-537F-C01D-27DC-3C4E35C98B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670301-2A32-825A-16DA-9843127F7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4889182-5651-BCC9-D5A2-658E5B2D4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7498CA-882B-6C5F-18FF-70A03AA05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977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E7747F-83ED-157B-2CE0-6F85AD4A9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57F0FA-4C49-3810-8FF1-0E5BAA8435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B3DF11E-E567-9807-EAE7-89A5A1161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68E2132-F7F3-0501-A406-34487ED52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FBFE19-4490-8E64-F84B-EE81D57AC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240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849968-8FA9-A400-4A88-A3C8019B3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5EDFDB0-93F6-5AED-4A1B-6AD7CB88BF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A4FFDA-17B5-3092-E7BF-E5138A99A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8150FA-E42D-DAB7-4658-69AC0546A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9C0208-D7FB-742A-C8EE-24587A87E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50877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46ABD3-735F-8F7A-ADE8-D45F717B7A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3922E47-BD59-8B5B-AFA4-1BED50861D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D5C4E14-6427-D30F-3ECD-2A4B1BEA65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3AAEEA6-CB35-DB0D-04AA-D048D8716E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E52EAE9-7335-5274-6DF4-B0E157A0AB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AC56DB6-5894-7F94-55D5-EDA1B3DF5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505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0D8C90-D5BE-7E39-CA5A-36616A1CCF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D094C7A-043B-6626-5F01-66DD708A05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FD75FB6-E9CD-3C94-BEBB-13AF97EB96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A5765A2-51DB-AA25-B5B4-24F452CF6A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F629E55-EE66-68CD-C46E-98B8119404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A32E3BB-F8C1-67A4-ED25-E979E01CC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CD564F2-41DC-9A35-AD5A-72891662F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93B0D1C-643B-EDFC-77DD-61BBAB5D69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2210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83E308-1F5A-A33A-0271-549C7E547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E3AEDEA-66E8-9702-221D-8BE2ABAE5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B3846AC-494F-E1F6-EE07-7959265F1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F3F619D-716F-592D-2519-E4E37D7BB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232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9DC222-548F-6BE4-5A86-60D778FB9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497E57A-397B-812E-5AA3-3547FCB28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F9FEE5C-D38D-A571-62DE-2A35E9EDD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975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E4FC37-DE6F-46E6-1766-E33110D5D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27FEEA2-E33B-DF4E-56C8-1AF0F3CB5F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54375C6-7773-43E0-B12C-61E84FB75C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2D4152-C0D0-2054-5C4D-AFC724835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1E41E08-720B-E608-A69C-5489747D1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36A6ACD-17C1-D98C-62B2-E8D29A79D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912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8A35DC-D2F1-ECC9-BB6C-39E6A4015A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0602AE7-FAD4-5BA3-A2E5-0DE2EC7F89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C8AAD37-D7E0-03B8-2715-0AD2A6CF8D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E4CE749-71D6-18DC-334C-ECBD364CE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4C6A05A-D889-4995-F14F-4EDD21328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A4177D-0E6C-A7C9-8003-0CC034B4B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644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7915520-494F-C914-9A75-D369E97C40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5639CA1-2D9B-5D49-A7D2-EF22C7AE80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73DBF65-0ED7-9951-3E1B-F32CBF24E5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65B6BFA-9C28-5441-93E3-C6E577923C96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B0A9FA9-B1F5-552A-0B98-6BA8E4F3FA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5277BE-9795-5523-C26A-7615FCBF09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00962D-7A76-F346-9238-701883694B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509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BF6188-ED1D-C645-AC52-A30FA8A123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11424" y="0"/>
            <a:ext cx="10515600" cy="596900"/>
          </a:xfrm>
        </p:spPr>
        <p:txBody>
          <a:bodyPr>
            <a:norm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: Comparison of perioperative KOOS sub-score between </a:t>
            </a:r>
            <a:r>
              <a:rPr kumimoji="1" lang="en-US" altLang="ja-JP" sz="1200" b="0" i="0" u="none" strike="noStrike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UKA </a:t>
            </a:r>
            <a:r>
              <a:rPr kumimoji="1" lang="en-US" altLang="ja-JP" sz="1200" kern="12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and </a:t>
            </a:r>
            <a:r>
              <a:rPr kumimoji="1" lang="en-US" altLang="ja-JP" sz="1200" b="0" i="0" u="none" strike="noStrike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OWHTO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D04D369-6C06-E74D-BD8A-B6C9E74BF212}"/>
              </a:ext>
            </a:extLst>
          </p:cNvPr>
          <p:cNvSpPr txBox="1"/>
          <p:nvPr/>
        </p:nvSpPr>
        <p:spPr>
          <a:xfrm>
            <a:off x="911423" y="6324062"/>
            <a:ext cx="101555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ues are expressed as mean and standard deviations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ld values indicate that statistically significant differences. </a:t>
            </a:r>
            <a:r>
              <a:rPr lang="en" altLang="ja-JP" sz="1200" b="0" i="1" u="none" strike="noStrike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OOS</a:t>
            </a:r>
            <a:r>
              <a:rPr lang="en" altLang="ja-JP" sz="1200" b="0" i="0" u="none" strike="noStrike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Knee Injury and Osteoarthritis Outcome Score;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K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compartmenta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nee arthroplasty</a:t>
            </a:r>
            <a:r>
              <a:rPr kumimoji="1"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WHTO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pening wedge high tibial osteotomy;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200" b="0" i="1" u="none" strike="noStrike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DL</a:t>
            </a:r>
            <a:r>
              <a:rPr lang="en" altLang="ja-JP" sz="1200" b="0" i="0" u="none" strike="noStrike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activities of daily living; </a:t>
            </a:r>
            <a:r>
              <a:rPr lang="en" altLang="ja-JP" sz="1200" b="0" i="1" u="none" strike="noStrike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QOL</a:t>
            </a:r>
            <a:r>
              <a:rPr lang="en" altLang="ja-JP" sz="1200" b="0" i="0" u="none" strike="noStrike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quality of life</a:t>
            </a:r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コンテンツ プレースホルダー 10">
            <a:extLst>
              <a:ext uri="{FF2B5EF4-FFF2-40B4-BE49-F238E27FC236}">
                <a16:creationId xmlns:a16="http://schemas.microsoft.com/office/drawing/2014/main" id="{52569073-A35E-F10E-330A-CB976CD0DB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1377130"/>
              </p:ext>
            </p:extLst>
          </p:nvPr>
        </p:nvGraphicFramePr>
        <p:xfrm>
          <a:off x="911424" y="476672"/>
          <a:ext cx="10155561" cy="576348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73725">
                  <a:extLst>
                    <a:ext uri="{9D8B030D-6E8A-4147-A177-3AD203B41FA5}">
                      <a16:colId xmlns:a16="http://schemas.microsoft.com/office/drawing/2014/main" val="1936941418"/>
                    </a:ext>
                  </a:extLst>
                </a:gridCol>
                <a:gridCol w="1721405">
                  <a:extLst>
                    <a:ext uri="{9D8B030D-6E8A-4147-A177-3AD203B41FA5}">
                      <a16:colId xmlns:a16="http://schemas.microsoft.com/office/drawing/2014/main" val="4246937277"/>
                    </a:ext>
                  </a:extLst>
                </a:gridCol>
                <a:gridCol w="2876403">
                  <a:extLst>
                    <a:ext uri="{9D8B030D-6E8A-4147-A177-3AD203B41FA5}">
                      <a16:colId xmlns:a16="http://schemas.microsoft.com/office/drawing/2014/main" val="2837905054"/>
                    </a:ext>
                  </a:extLst>
                </a:gridCol>
                <a:gridCol w="2217227">
                  <a:extLst>
                    <a:ext uri="{9D8B030D-6E8A-4147-A177-3AD203B41FA5}">
                      <a16:colId xmlns:a16="http://schemas.microsoft.com/office/drawing/2014/main" val="600728822"/>
                    </a:ext>
                  </a:extLst>
                </a:gridCol>
                <a:gridCol w="1166801">
                  <a:extLst>
                    <a:ext uri="{9D8B030D-6E8A-4147-A177-3AD203B41FA5}">
                      <a16:colId xmlns:a16="http://schemas.microsoft.com/office/drawing/2014/main" val="4089931696"/>
                    </a:ext>
                  </a:extLst>
                </a:gridCol>
              </a:tblGrid>
              <a:tr h="2185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UKA (n=50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OWHTO (n=50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5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alu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3358310"/>
                  </a:ext>
                </a:extLst>
              </a:tr>
              <a:tr h="299812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OS</a:t>
                      </a:r>
                      <a:r>
                        <a:rPr lang="ja-JP" altLang="en-US" sz="105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　　　　　</a:t>
                      </a:r>
                      <a:r>
                        <a:rPr lang="en-US" altLang="ja-JP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" altLang="ja-JP" sz="105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ptoms</a:t>
                      </a: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1372640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r>
                        <a:rPr lang="ja-JP" altLang="en-US" sz="105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reoperativ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6.5 ± 3.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5.4 ± 4.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28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2574773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5.4 ± 3.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7.6 ± 4.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 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9687319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9.4 ± 4.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9.7 ± 3.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3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4200291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4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7.0 ± 4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9.8 ± 2.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 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6364562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5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n </a:t>
                      </a: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2297681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5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reoperativ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5.4 ± 4.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5.2 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± 4.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9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8920696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5.9 ± 4.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7.7 ± 5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 0.001</a:t>
                      </a: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9603877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7.3 ± 5.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0.9 ± 2.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 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9201137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4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1.9 ± 4.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0.9 ± 2.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4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1623639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5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L</a:t>
                      </a: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157138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reoperativ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4.8 ± 8.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3.9 ± 8.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0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9858143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0.1 ± 8.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3.4 ± 5.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 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962317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4.1 ± 6.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2.1 ± 5.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78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3771285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4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3.9 ± 5.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3.8 ± 4.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7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4745638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5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orts/rec</a:t>
                      </a: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0960958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reoperativ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2.2 ± 9.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9 ± 9.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5</a:t>
                      </a: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6042672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3.9 ± 14.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2.7 ± 11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lt; 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5123098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1.5 ± 13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7.2 ± 10.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7</a:t>
                      </a: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1275599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4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1.8 ± 13.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7.2 ± 10.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26</a:t>
                      </a: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0141390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5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OL</a:t>
                      </a: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9672231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reoperativ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8 ± 6.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1.5 ± 6.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41</a:t>
                      </a: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6461281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1.2 ± 7.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9.2 ± 5.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1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5328180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0.6 ± 6.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2.3 ± 5.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6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3602124"/>
                  </a:ext>
                </a:extLst>
              </a:tr>
              <a:tr h="218547">
                <a:tc>
                  <a:txBody>
                    <a:bodyPr/>
                    <a:lstStyle/>
                    <a:p>
                      <a:pPr algn="r"/>
                      <a:endParaRPr lang="en" altLang="ja-JP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4 month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0.0 ± 9.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4.5 ± 6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altLang="ja-JP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2</a:t>
                      </a:r>
                      <a:endParaRPr lang="en-US" altLang="ja-JP" sz="105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07815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99605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4</Words>
  <Application>Microsoft Macintosh PowerPoint</Application>
  <PresentationFormat>ワイド画面</PresentationFormat>
  <Paragraphs>9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upplemental table: Comparison of perioperative KOOS sub-score between UKA and OWHTO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慎太郎 大西</dc:creator>
  <cp:lastModifiedBy>慎太郎 大西</cp:lastModifiedBy>
  <cp:revision>2</cp:revision>
  <dcterms:created xsi:type="dcterms:W3CDTF">2024-09-21T20:12:49Z</dcterms:created>
  <dcterms:modified xsi:type="dcterms:W3CDTF">2024-09-22T07:56:32Z</dcterms:modified>
</cp:coreProperties>
</file>